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79F243D-BD89-4FCB-BC98-2A36E871EA2E}" v="1" dt="2025-07-09T19:45:40.473"/>
    <p1510:client id="{80991548-4828-4B0C-8472-EAC2B0178C3A}" v="4" dt="2025-07-09T19:35:46.278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B9631B5-78F2-41C9-869B-9F39066F8104}" styleName="Medium Style 3 – 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9" d="100"/>
          <a:sy n="89" d="100"/>
        </p:scale>
        <p:origin x="787" y="3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vids, Daniel" userId="bd69870e-14b0-4b2a-a293-a297d41864dd" providerId="ADAL" clId="{079F243D-BD89-4FCB-BC98-2A36E871EA2E}"/>
    <pc:docChg chg="custSel modSld">
      <pc:chgData name="Davids, Daniel" userId="bd69870e-14b0-4b2a-a293-a297d41864dd" providerId="ADAL" clId="{079F243D-BD89-4FCB-BC98-2A36E871EA2E}" dt="2025-07-09T19:46:26.957" v="18" actId="14100"/>
      <pc:docMkLst>
        <pc:docMk/>
      </pc:docMkLst>
      <pc:sldChg chg="addSp delSp modSp mod">
        <pc:chgData name="Davids, Daniel" userId="bd69870e-14b0-4b2a-a293-a297d41864dd" providerId="ADAL" clId="{079F243D-BD89-4FCB-BC98-2A36E871EA2E}" dt="2025-07-09T19:46:26.957" v="18" actId="14100"/>
        <pc:sldMkLst>
          <pc:docMk/>
          <pc:sldMk cId="174092475" sldId="257"/>
        </pc:sldMkLst>
        <pc:graphicFrameChg chg="add mod modGraphic">
          <ac:chgData name="Davids, Daniel" userId="bd69870e-14b0-4b2a-a293-a297d41864dd" providerId="ADAL" clId="{079F243D-BD89-4FCB-BC98-2A36E871EA2E}" dt="2025-07-09T19:46:26.957" v="18" actId="14100"/>
          <ac:graphicFrameMkLst>
            <pc:docMk/>
            <pc:sldMk cId="174092475" sldId="257"/>
            <ac:graphicFrameMk id="2" creationId="{77370CC2-7FCD-FC96-392D-09C9DD6C5407}"/>
          </ac:graphicFrameMkLst>
        </pc:graphicFrameChg>
        <pc:graphicFrameChg chg="del">
          <ac:chgData name="Davids, Daniel" userId="bd69870e-14b0-4b2a-a293-a297d41864dd" providerId="ADAL" clId="{079F243D-BD89-4FCB-BC98-2A36E871EA2E}" dt="2025-07-09T19:45:32.179" v="0" actId="478"/>
          <ac:graphicFrameMkLst>
            <pc:docMk/>
            <pc:sldMk cId="174092475" sldId="257"/>
            <ac:graphicFrameMk id="4" creationId="{E0B12A61-35CD-6C46-A602-47E37FE98DF0}"/>
          </ac:graphicFrameMkLst>
        </pc:graphicFrameChg>
      </pc:sldChg>
    </pc:docChg>
  </pc:docChgLst>
  <pc:docChgLst>
    <pc:chgData name="Davids, Daniel" userId="bd69870e-14b0-4b2a-a293-a297d41864dd" providerId="ADAL" clId="{F360EA8D-2CEF-44DC-A095-62624361F870}"/>
    <pc:docChg chg="custSel addSld modSld">
      <pc:chgData name="Davids, Daniel" userId="bd69870e-14b0-4b2a-a293-a297d41864dd" providerId="ADAL" clId="{F360EA8D-2CEF-44DC-A095-62624361F870}" dt="2024-11-03T19:02:12.238" v="30" actId="1035"/>
      <pc:docMkLst>
        <pc:docMk/>
      </pc:docMkLst>
      <pc:sldChg chg="addSp delSp modSp mod">
        <pc:chgData name="Davids, Daniel" userId="bd69870e-14b0-4b2a-a293-a297d41864dd" providerId="ADAL" clId="{F360EA8D-2CEF-44DC-A095-62624361F870}" dt="2024-11-03T19:02:12.238" v="30" actId="1035"/>
        <pc:sldMkLst>
          <pc:docMk/>
          <pc:sldMk cId="174092475" sldId="257"/>
        </pc:sldMkLst>
      </pc:sldChg>
      <pc:sldChg chg="delSp modSp add mod">
        <pc:chgData name="Davids, Daniel" userId="bd69870e-14b0-4b2a-a293-a297d41864dd" providerId="ADAL" clId="{F360EA8D-2CEF-44DC-A095-62624361F870}" dt="2024-11-03T18:56:55.974" v="23" actId="20577"/>
        <pc:sldMkLst>
          <pc:docMk/>
          <pc:sldMk cId="3475097194" sldId="258"/>
        </pc:sldMkLst>
      </pc:sldChg>
    </pc:docChg>
  </pc:docChgLst>
  <pc:docChgLst>
    <pc:chgData name="Davids, Daniel" userId="bd69870e-14b0-4b2a-a293-a297d41864dd" providerId="ADAL" clId="{6A553EA6-244C-48F8-95FD-828D1717A47C}"/>
    <pc:docChg chg="custSel addSld delSld modSld">
      <pc:chgData name="Davids, Daniel" userId="bd69870e-14b0-4b2a-a293-a297d41864dd" providerId="ADAL" clId="{6A553EA6-244C-48F8-95FD-828D1717A47C}" dt="2025-03-05T23:50:11.992" v="16" actId="1076"/>
      <pc:docMkLst>
        <pc:docMk/>
      </pc:docMkLst>
      <pc:sldChg chg="addSp delSp modSp mod">
        <pc:chgData name="Davids, Daniel" userId="bd69870e-14b0-4b2a-a293-a297d41864dd" providerId="ADAL" clId="{6A553EA6-244C-48F8-95FD-828D1717A47C}" dt="2025-03-05T23:50:11.992" v="16" actId="1076"/>
        <pc:sldMkLst>
          <pc:docMk/>
          <pc:sldMk cId="174092475" sldId="257"/>
        </pc:sldMkLst>
      </pc:sldChg>
      <pc:sldChg chg="del">
        <pc:chgData name="Davids, Daniel" userId="bd69870e-14b0-4b2a-a293-a297d41864dd" providerId="ADAL" clId="{6A553EA6-244C-48F8-95FD-828D1717A47C}" dt="2025-03-05T21:20:23.750" v="3" actId="47"/>
        <pc:sldMkLst>
          <pc:docMk/>
          <pc:sldMk cId="3475097194" sldId="258"/>
        </pc:sldMkLst>
      </pc:sldChg>
      <pc:sldChg chg="add del">
        <pc:chgData name="Davids, Daniel" userId="bd69870e-14b0-4b2a-a293-a297d41864dd" providerId="ADAL" clId="{6A553EA6-244C-48F8-95FD-828D1717A47C}" dt="2025-03-05T21:20:16.677" v="2" actId="47"/>
        <pc:sldMkLst>
          <pc:docMk/>
          <pc:sldMk cId="4035310119" sldId="259"/>
        </pc:sldMkLst>
      </pc:sldChg>
      <pc:sldChg chg="add del">
        <pc:chgData name="Davids, Daniel" userId="bd69870e-14b0-4b2a-a293-a297d41864dd" providerId="ADAL" clId="{6A553EA6-244C-48F8-95FD-828D1717A47C}" dt="2025-03-05T21:20:16.677" v="2" actId="47"/>
        <pc:sldMkLst>
          <pc:docMk/>
          <pc:sldMk cId="3572187018" sldId="260"/>
        </pc:sldMkLst>
      </pc:sldChg>
    </pc:docChg>
  </pc:docChgLst>
  <pc:docChgLst>
    <pc:chgData name="Davids, Daniel" userId="bd69870e-14b0-4b2a-a293-a297d41864dd" providerId="ADAL" clId="{B0D606D2-1008-41BC-A72F-F713ABC021F4}"/>
    <pc:docChg chg="addSld delSld modSld">
      <pc:chgData name="Davids, Daniel" userId="bd69870e-14b0-4b2a-a293-a297d41864dd" providerId="ADAL" clId="{B0D606D2-1008-41BC-A72F-F713ABC021F4}" dt="2024-11-03T18:32:44.267" v="35" actId="47"/>
      <pc:docMkLst>
        <pc:docMk/>
      </pc:docMkLst>
      <pc:sldChg chg="new del">
        <pc:chgData name="Davids, Daniel" userId="bd69870e-14b0-4b2a-a293-a297d41864dd" providerId="ADAL" clId="{B0D606D2-1008-41BC-A72F-F713ABC021F4}" dt="2024-11-03T18:19:33.782" v="2" actId="47"/>
        <pc:sldMkLst>
          <pc:docMk/>
          <pc:sldMk cId="2106742275" sldId="256"/>
        </pc:sldMkLst>
      </pc:sldChg>
      <pc:sldChg chg="addSp delSp modSp new mod">
        <pc:chgData name="Davids, Daniel" userId="bd69870e-14b0-4b2a-a293-a297d41864dd" providerId="ADAL" clId="{B0D606D2-1008-41BC-A72F-F713ABC021F4}" dt="2024-11-03T18:31:45.297" v="32" actId="14100"/>
        <pc:sldMkLst>
          <pc:docMk/>
          <pc:sldMk cId="174092475" sldId="257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261132528" sldId="258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129412391" sldId="259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459212972" sldId="260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083949308" sldId="261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847408672" sldId="262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110391834" sldId="263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546292502" sldId="264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035228439" sldId="265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1002150119" sldId="266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2056411075" sldId="267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3923372120" sldId="268"/>
        </pc:sldMkLst>
      </pc:sldChg>
      <pc:sldChg chg="add del">
        <pc:chgData name="Davids, Daniel" userId="bd69870e-14b0-4b2a-a293-a297d41864dd" providerId="ADAL" clId="{B0D606D2-1008-41BC-A72F-F713ABC021F4}" dt="2024-11-03T18:32:44.267" v="35" actId="47"/>
        <pc:sldMkLst>
          <pc:docMk/>
          <pc:sldMk cId="752528510" sldId="269"/>
        </pc:sldMkLst>
      </pc:sldChg>
      <pc:sldChg chg="add del">
        <pc:chgData name="Davids, Daniel" userId="bd69870e-14b0-4b2a-a293-a297d41864dd" providerId="ADAL" clId="{B0D606D2-1008-41BC-A72F-F713ABC021F4}" dt="2024-11-03T18:32:35.079" v="34" actId="47"/>
        <pc:sldMkLst>
          <pc:docMk/>
          <pc:sldMk cId="2664668440" sldId="270"/>
        </pc:sldMkLst>
      </pc:sldChg>
      <pc:sldChg chg="add del">
        <pc:chgData name="Davids, Daniel" userId="bd69870e-14b0-4b2a-a293-a297d41864dd" providerId="ADAL" clId="{B0D606D2-1008-41BC-A72F-F713ABC021F4}" dt="2024-11-03T18:32:35.079" v="34" actId="47"/>
        <pc:sldMkLst>
          <pc:docMk/>
          <pc:sldMk cId="107856901" sldId="271"/>
        </pc:sldMkLst>
      </pc:sldChg>
      <pc:sldChg chg="add del">
        <pc:chgData name="Davids, Daniel" userId="bd69870e-14b0-4b2a-a293-a297d41864dd" providerId="ADAL" clId="{B0D606D2-1008-41BC-A72F-F713ABC021F4}" dt="2024-11-03T18:32:32.890" v="33" actId="47"/>
        <pc:sldMkLst>
          <pc:docMk/>
          <pc:sldMk cId="1885141936" sldId="272"/>
        </pc:sldMkLst>
      </pc:sldChg>
    </pc:docChg>
  </pc:docChgLst>
  <pc:docChgLst>
    <pc:chgData name="Davids, Daniel" userId="bd69870e-14b0-4b2a-a293-a297d41864dd" providerId="ADAL" clId="{80991548-4828-4B0C-8472-EAC2B0178C3A}"/>
    <pc:docChg chg="custSel modSld">
      <pc:chgData name="Davids, Daniel" userId="bd69870e-14b0-4b2a-a293-a297d41864dd" providerId="ADAL" clId="{80991548-4828-4B0C-8472-EAC2B0178C3A}" dt="2025-07-09T19:35:53.748" v="3" actId="1076"/>
      <pc:docMkLst>
        <pc:docMk/>
      </pc:docMkLst>
      <pc:sldChg chg="addSp delSp modSp mod">
        <pc:chgData name="Davids, Daniel" userId="bd69870e-14b0-4b2a-a293-a297d41864dd" providerId="ADAL" clId="{80991548-4828-4B0C-8472-EAC2B0178C3A}" dt="2025-07-09T19:35:53.748" v="3" actId="1076"/>
        <pc:sldMkLst>
          <pc:docMk/>
          <pc:sldMk cId="174092475" sldId="257"/>
        </pc:sldMkLst>
        <pc:graphicFrameChg chg="add mod">
          <ac:chgData name="Davids, Daniel" userId="bd69870e-14b0-4b2a-a293-a297d41864dd" providerId="ADAL" clId="{80991548-4828-4B0C-8472-EAC2B0178C3A}" dt="2025-07-09T19:35:38.190" v="1"/>
          <ac:graphicFrameMkLst>
            <pc:docMk/>
            <pc:sldMk cId="174092475" sldId="257"/>
            <ac:graphicFrameMk id="2" creationId="{E32B4A51-178D-C890-AB83-2FB66FFC672E}"/>
          </ac:graphicFrameMkLst>
        </pc:graphicFrameChg>
        <pc:graphicFrameChg chg="del">
          <ac:chgData name="Davids, Daniel" userId="bd69870e-14b0-4b2a-a293-a297d41864dd" providerId="ADAL" clId="{80991548-4828-4B0C-8472-EAC2B0178C3A}" dt="2025-07-09T19:33:30.622" v="0" actId="478"/>
          <ac:graphicFrameMkLst>
            <pc:docMk/>
            <pc:sldMk cId="174092475" sldId="257"/>
            <ac:graphicFrameMk id="3" creationId="{628EA2F4-7C09-610F-3DE6-012586300E54}"/>
          </ac:graphicFrameMkLst>
        </pc:graphicFrameChg>
        <pc:graphicFrameChg chg="add mod">
          <ac:chgData name="Davids, Daniel" userId="bd69870e-14b0-4b2a-a293-a297d41864dd" providerId="ADAL" clId="{80991548-4828-4B0C-8472-EAC2B0178C3A}" dt="2025-07-09T19:35:53.748" v="3" actId="1076"/>
          <ac:graphicFrameMkLst>
            <pc:docMk/>
            <pc:sldMk cId="174092475" sldId="257"/>
            <ac:graphicFrameMk id="4" creationId="{E0B12A61-35CD-6C46-A602-47E37FE98DF0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04686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76092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91971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80267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65694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02484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7901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50910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62804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56778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22955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00C48F6-9C02-4FB5-B5A2-9565999CEFAA}" type="datetimeFigureOut">
              <a:rPr lang="en-GB" smtClean="0"/>
              <a:t>09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E7C343B-DE28-4A0A-9449-6C56F546CE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19663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77370CC2-7FCD-FC96-392D-09C9DD6C540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55432388"/>
              </p:ext>
            </p:extLst>
          </p:nvPr>
        </p:nvGraphicFramePr>
        <p:xfrm>
          <a:off x="2639694" y="2057432"/>
          <a:ext cx="7032944" cy="1463040"/>
        </p:xfrm>
        <a:graphic>
          <a:graphicData uri="http://schemas.openxmlformats.org/drawingml/2006/table">
            <a:tbl>
              <a:tblPr firstRow="1" firstCol="1" bandRow="1"/>
              <a:tblGrid>
                <a:gridCol w="1923303">
                  <a:extLst>
                    <a:ext uri="{9D8B030D-6E8A-4147-A177-3AD203B41FA5}">
                      <a16:colId xmlns:a16="http://schemas.microsoft.com/office/drawing/2014/main" val="2102760908"/>
                    </a:ext>
                  </a:extLst>
                </a:gridCol>
                <a:gridCol w="1498199">
                  <a:extLst>
                    <a:ext uri="{9D8B030D-6E8A-4147-A177-3AD203B41FA5}">
                      <a16:colId xmlns:a16="http://schemas.microsoft.com/office/drawing/2014/main" val="1975539645"/>
                    </a:ext>
                  </a:extLst>
                </a:gridCol>
                <a:gridCol w="1224918">
                  <a:extLst>
                    <a:ext uri="{9D8B030D-6E8A-4147-A177-3AD203B41FA5}">
                      <a16:colId xmlns:a16="http://schemas.microsoft.com/office/drawing/2014/main" val="3877264854"/>
                    </a:ext>
                  </a:extLst>
                </a:gridCol>
                <a:gridCol w="1180341">
                  <a:extLst>
                    <a:ext uri="{9D8B030D-6E8A-4147-A177-3AD203B41FA5}">
                      <a16:colId xmlns:a16="http://schemas.microsoft.com/office/drawing/2014/main" val="1091430395"/>
                    </a:ext>
                  </a:extLst>
                </a:gridCol>
                <a:gridCol w="1206183">
                  <a:extLst>
                    <a:ext uri="{9D8B030D-6E8A-4147-A177-3AD203B41FA5}">
                      <a16:colId xmlns:a16="http://schemas.microsoft.com/office/drawing/2014/main" val="3827239533"/>
                    </a:ext>
                  </a:extLst>
                </a:gridCol>
              </a:tblGrid>
              <a:tr h="182880">
                <a:tc gridSpan="5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y = Intercept + B1*x^1 + B2*x^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908152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lot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5% Capture Rat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0% Capture Rat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5% Capture Rat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7% Capture Rat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7793406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Intercept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8.67771 ± 0.3933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6.33156 ± 0.5926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5.02403 ± 0.8429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5.01433 ± 0.6403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29388428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.91163 ± 1.8721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3.87701 ± 3.2365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  <a:tabLst/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5.19925 ± 5.38308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2.4127 ± 4.3761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9344466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B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2.95972 ± 1.9071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10.87576 ± 3.6629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9.9645 ± 6.8489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-5.68767 ± 5.8574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386323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esidual Sum of Squares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0513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1895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66275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4847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3083008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-Square (COD)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497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643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5164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686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2604213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b="1" i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dj. R-Square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89939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2876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0328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1000"/>
                        </a:spcAft>
                        <a:buNone/>
                      </a:pPr>
                      <a:r>
                        <a:rPr lang="en-US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3737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3667952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40924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</TotalTime>
  <Words>98</Words>
  <Application>Microsoft Office PowerPoint</Application>
  <PresentationFormat>Widescreen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avids, Daniel</dc:creator>
  <cp:lastModifiedBy>Davids, Daniel</cp:lastModifiedBy>
  <cp:revision>1</cp:revision>
  <dcterms:created xsi:type="dcterms:W3CDTF">2024-11-03T18:19:26Z</dcterms:created>
  <dcterms:modified xsi:type="dcterms:W3CDTF">2025-07-09T19:46:31Z</dcterms:modified>
</cp:coreProperties>
</file>